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3325" cy="22860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39F94-0636-45C6-9511-59B4FC79B1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66280" y="6603840"/>
            <a:ext cx="641988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66280" y="13768200"/>
            <a:ext cx="641988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61A43-F14A-4D78-BC76-FAB4D09B3D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66280" y="660384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55960" y="660384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66280" y="1376820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55960" y="1376820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9D3F3-5D04-43DB-849B-7520141EDF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66280" y="6603840"/>
            <a:ext cx="20671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37080" y="6603840"/>
            <a:ext cx="20671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07880" y="6603840"/>
            <a:ext cx="20671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66280" y="13768200"/>
            <a:ext cx="20671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37080" y="13768200"/>
            <a:ext cx="20671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07880" y="13768200"/>
            <a:ext cx="20671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61DA3F-AA15-404C-963A-7E4356DE09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66280" y="6603840"/>
            <a:ext cx="6419880" cy="13716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12BE39-E748-419B-9681-D0743B87BA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66280" y="6603840"/>
            <a:ext cx="6419880" cy="137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6C874-771E-41B9-AF93-A6E2835A39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66280" y="6603840"/>
            <a:ext cx="3132720" cy="137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55960" y="6603840"/>
            <a:ext cx="3132720" cy="137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E717D-7732-43C3-AEEC-FFF62C3B28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B1C657-2727-45EC-A81E-223E35B743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66280" y="2031840"/>
            <a:ext cx="6419880" cy="1766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C01DA-540E-4620-9CE4-BDE0D49C52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66280" y="660384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55960" y="6603840"/>
            <a:ext cx="3132720" cy="137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66280" y="1376820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75D5D2-C3F1-4AC6-BADC-E34B38E2BD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66280" y="6603840"/>
            <a:ext cx="3132720" cy="137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55960" y="660384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55960" y="1376820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E0D6C8-D07C-4813-82C1-23C2203A99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66280" y="660384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55960" y="6603840"/>
            <a:ext cx="313272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66280" y="13768200"/>
            <a:ext cx="6419880" cy="6542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84B06-076A-45BC-996E-67CE070A49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66280" y="2031840"/>
            <a:ext cx="6419880" cy="381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66280" y="6603840"/>
            <a:ext cx="6419880" cy="137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66640" y="20827800"/>
            <a:ext cx="1573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0840" y="20827800"/>
            <a:ext cx="239076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3320" y="20827800"/>
            <a:ext cx="1573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EEFCC4-4C7E-407E-8F3A-A45C400A45BA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12520" y="22523400"/>
            <a:ext cx="2058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Xenopus laevis@NP_00108606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740600" y="22355280"/>
            <a:ext cx="175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Gallus gallus@NP_9897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798920" y="22220280"/>
            <a:ext cx="167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Homo sapiens@NP_00209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798920" y="22085280"/>
            <a:ext cx="167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us musculus@NP_03453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720440" y="21950280"/>
            <a:ext cx="1829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Danio rerio@NP_00108292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542960" y="21815280"/>
            <a:ext cx="2972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trongylocentrotus purpuratus@XP_7887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626840" y="21680640"/>
            <a:ext cx="2667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Nematostella vectensis@XP_0016389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785600" y="21545640"/>
            <a:ext cx="2210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Tribolium castaneum@XP_9756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814400" y="21410640"/>
            <a:ext cx="2439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aenorhabditis elegans@NP_5098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576080" y="21242160"/>
            <a:ext cx="335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Trypanosoma cruzi strain CL Brener@XP_82033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607760" y="21107520"/>
            <a:ext cx="289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Dictyostelium discoideum AX4@XP_6369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667520" y="20972520"/>
            <a:ext cx="160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Emiliania_huxleyi@jg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884960" y="20837520"/>
            <a:ext cx="1143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ureococcus@jg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697760" y="20702520"/>
            <a:ext cx="160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hytophtora_soiae@jg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765800" y="20567520"/>
            <a:ext cx="2210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erkinsus_marinus_EST_chimer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734120" y="20434320"/>
            <a:ext cx="160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Naegleria@EST_chimer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625400" y="20299320"/>
            <a:ext cx="2972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lastocladiella_emersonii_EST_gb_CO96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790640" y="20164320"/>
            <a:ext cx="358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aramecium tetraurelia strain d4-2@XP_001450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790640" y="19994400"/>
            <a:ext cx="358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aramecium tetraurelia strain d4-2@XP_00144638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370520" y="2100744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432440" y="1962936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234800" y="19859760"/>
            <a:ext cx="350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Thermoanaerobacter tengcongensis MB4@NP_6224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148040" y="19726200"/>
            <a:ext cx="3963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acillus subtilis subsp. subtilis str. 168@NP_3918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622880" y="19591200"/>
            <a:ext cx="2515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acillus cereus AH187@ZP_0225489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607040" y="19431000"/>
            <a:ext cx="3963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taphylococcus aureus subsp. aureus USA300@YP_4927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576800" y="19186560"/>
            <a:ext cx="312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treptococcus pyogenes MGAS9429@YP_5975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359360" y="19051560"/>
            <a:ext cx="4649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Fusobacterium nucleatum subsp. nucleatum ATCC 25586@NP_60368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208880" y="2063592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208880" y="196293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681560" y="1891656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Ferroplasma acidarmanus fer1@ZP_017093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589760" y="18748440"/>
            <a:ext cx="2972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icrophilus torridus DSM 9790@YP_02288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661040" y="18613440"/>
            <a:ext cx="327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hermoplasma acidophilum DSM 1728@NP_3937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684800" y="18478440"/>
            <a:ext cx="2820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Thermoplasma volcanium GSS1@NP_11187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599120" y="190515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594080" y="1834344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678680" y="18343440"/>
            <a:ext cx="2820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Thermotoga lettingae TMO@YP_00147015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479240" y="18208800"/>
            <a:ext cx="342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Fervidobacterium nodosum Rt17-B1@YP_0014096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356120" y="186688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370520" y="182577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230840" y="184863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634040" y="18059400"/>
            <a:ext cx="2820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ethylobacterium sp. 4-46@ZP_018450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594440" y="17938800"/>
            <a:ext cx="350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ethylobacterium nodulans ORS 2060@ZP_021181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551600" y="17816400"/>
            <a:ext cx="3886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Xanthomonas oryzae pv. oryzicola BLS256@ZP_0224377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704600" y="17668800"/>
            <a:ext cx="2820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aulobacter crescentus CB15@NP_4197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801440" y="17500680"/>
            <a:ext cx="327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radyrhizobium japonicum USDA 110@NP_77288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858680" y="17365680"/>
            <a:ext cx="327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oseobacter denitrificans OCh 114@YP_6838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751760" y="17230680"/>
            <a:ext cx="358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hodobacter sphaeroides ATCC 17029@YP_0010434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757880" y="17095680"/>
            <a:ext cx="327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artonella quintana str. Toulouse@YP_0323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627560" y="16960680"/>
            <a:ext cx="350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rucella abortus biovar 1 str. 9-941@YP_2230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919880" y="16826040"/>
            <a:ext cx="2439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esorhizobium sp. BNC1@YP_6755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664280" y="16691040"/>
            <a:ext cx="373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hizobium leguminosarum bv. viciae 3841@YP_7712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954800" y="166575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878840" y="1675764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827720" y="169275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721160" y="1712916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720440" y="16556040"/>
            <a:ext cx="320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urkholderia pseudomallei 668@YP_0010596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878480" y="16421040"/>
            <a:ext cx="320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Legionella pneumophila str. Lens@YP_12668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549800" y="16252920"/>
            <a:ext cx="4801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Yersinia enterocolitica subsp. enterocolitica 8081@YP_0010082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918440" y="16117920"/>
            <a:ext cx="289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seudomonas fluorescens Pf-5@YP_25755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078280" y="15982920"/>
            <a:ext cx="19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seudomonas putida@P213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941120" y="15847920"/>
            <a:ext cx="2286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oritella sp. PE36@ZP_019001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919880" y="15712920"/>
            <a:ext cx="2515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Vibrio cholerae MZO-3@ZP_0195805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975320" y="1635444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666080" y="154684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904040" y="1578132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840680" y="1598292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624680" y="1559088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alstonia solanacearum GMI1000@NP_5207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613520" y="15443280"/>
            <a:ext cx="2667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alstonia pickettii 12D@ZP_0200688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666080" y="1655604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508400" y="152398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589760" y="159256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635120" y="15308280"/>
            <a:ext cx="289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alinibacter ruber DSM 13855@YP_4448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763640" y="15140160"/>
            <a:ext cx="289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orphyromonas gingivalis W83@NP_9046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776960" y="15005160"/>
            <a:ext cx="312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icroscilla marina ATCC 23134@ZP_0168708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505520" y="1487016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340280" y="169606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345320" y="1521000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450800" y="14870160"/>
            <a:ext cx="320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dellovibrio bacteriovorus HD100@NP_9695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531800" y="14735160"/>
            <a:ext cx="2743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yxococcus xanthus DK 1622@YP_63166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400040" y="14600160"/>
            <a:ext cx="320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orangium cellulosum So ce 56@YP_00161672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332720" y="144651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603080" y="14465160"/>
            <a:ext cx="327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Haloarcula marismortui ATCC 43049@YP_13638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747800" y="14330520"/>
            <a:ext cx="2515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Halobacterium sp. NRC-1@NP_4442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1842120" y="14195520"/>
            <a:ext cx="373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hizobium leguminosarum bv. viciae 3841@YP_7712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479960" y="1460016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543320" y="14060520"/>
            <a:ext cx="327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ubrobacter xylanophilus DSM 9941@YP_6433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614960" y="13892040"/>
            <a:ext cx="350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ycobacterium smegmatis str. MC2 155@YP_8855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713240" y="13757400"/>
            <a:ext cx="236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treptomyces avermitilis@Q82I3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378440" y="137574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404000" y="1362240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Gloeobacter violaceus PCC 7421@NP_9260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1505520" y="13487400"/>
            <a:ext cx="373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Herpetosiphon aurantiacus ATCC 23779@YP_00154738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424520" y="13352400"/>
            <a:ext cx="342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hloroflexus aurantiacus J-10-fl@YP_00163459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383480" y="1321740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359360" y="13217400"/>
            <a:ext cx="289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alstonia metallidurans CH34@YP_58238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348920" y="13082760"/>
            <a:ext cx="320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alinispora arenicola CNS-205@YP_0015369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450800" y="12947760"/>
            <a:ext cx="2515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treptomyces globisporus@AAL066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365480" y="128142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699920" y="12814200"/>
            <a:ext cx="312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Halorhodospira halophila SL1@YP_00100338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1586520" y="12644280"/>
            <a:ext cx="358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hodobacter sphaeroides ATCC 17029@YP_0010451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576800" y="12509640"/>
            <a:ext cx="2972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hodobacter sphaeroides 2.4.1@YP_3550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1279800" y="1231416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761840" y="12374640"/>
            <a:ext cx="289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alinibacter ruber DSM 13855@YP_4448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464200" y="12239640"/>
            <a:ext cx="2591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accharothrix espanaensis@ABC8866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361160" y="1303020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294560" y="1210644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073520" y="133192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132560" y="124966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1499760" y="12106440"/>
            <a:ext cx="350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Desulfuromonas acetoxidans DSM 684@ZP_0131227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686600" y="11971440"/>
            <a:ext cx="335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Flavobacterium johnsoniae UW101@YP_0011934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652400" y="11836440"/>
            <a:ext cx="327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ytophaga hutchinsonii ATCC 33406@YP_67872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1432440" y="118872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767240" y="11701440"/>
            <a:ext cx="236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treptomyces maritimus@AAF817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810440" y="11566440"/>
            <a:ext cx="2134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antoea agglomerans@AAO391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681560" y="1139652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Vibrionales bacterium SWAT-3@ZP_018154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1746720" y="1126332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132560" y="1196352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7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1661040" y="114300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788120" y="11263320"/>
            <a:ext cx="342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aldivirga maquilingensis IC-167@YP_00154135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845720" y="11128320"/>
            <a:ext cx="350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yrobaculum arsenaticum DSM 13514@YP_0011536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695960" y="10993320"/>
            <a:ext cx="327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ubrobacter xylanophilus DSM 9941@YP_6445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926000" y="10858680"/>
            <a:ext cx="2972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seudomonas fluorescens PfO-1@YP_34616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131560" y="10723680"/>
            <a:ext cx="2286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oritella sp. PE36@ZP_018969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075400" y="10588680"/>
            <a:ext cx="2667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Vibrio splendidus 12B01@ZP_009909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093760" y="10453680"/>
            <a:ext cx="289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hotobacterium profundum SS9@YP_13178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991160" y="10318680"/>
            <a:ext cx="335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hewanella pealeana ATCC 700345@YP_0015037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022120" y="10150560"/>
            <a:ext cx="2820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hewanella baltica OS155@YP_00104873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018520" y="102171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938960" y="1001556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alstonia solanacearum GMI1000@NP_52192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1926000" y="9880560"/>
            <a:ext cx="320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urkholderia vietnamiensis G4@YP_0011151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818360" y="108586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949760" y="974556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1661040" y="1025676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064960" y="9745560"/>
            <a:ext cx="289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Dictyostelium discoideum AX4@XP_6445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562400" y="9610560"/>
            <a:ext cx="4801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Yersinia enterocolitica subsp. enterocolitica 8081@YP_0010072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1861920" y="9475920"/>
            <a:ext cx="4267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hotorhabdus luminescens subsp. laumondii TTO1@NP_9294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1894680" y="95248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1279800" y="108586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352880" y="944244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1938600" y="9340920"/>
            <a:ext cx="2820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ethylobacterium sp. 4-46@ZP_018465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1949760" y="9205920"/>
            <a:ext cx="373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Herpetosiphon aurantiacus ATCC 23779@YP_00154517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1937160" y="9070920"/>
            <a:ext cx="373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Herpetosiphon aurantiacus ATCC 23779@YP_00154465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2004840" y="890280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nabaena variabilis ATCC 29413@YP_32448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2002320" y="876780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Nostoc punctiforme PCC 73102@ZP_001059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089440" y="91440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199240" y="853452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1813320" y="89614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256480" y="8632800"/>
            <a:ext cx="2439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hodosporidium toruloides@1Y2M_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277720" y="8497800"/>
            <a:ext cx="236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Rhodotorula mucilaginosa@P102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277720" y="8362800"/>
            <a:ext cx="2210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Ustilago maydis 521@XP_7562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225160" y="8228160"/>
            <a:ext cx="2591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Lentinula_edodes_EST_gb_EB014275_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250000" y="8093160"/>
            <a:ext cx="2667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Laccaria bicolor S238N-H82@EDR090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2390760" y="7958160"/>
            <a:ext cx="175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manita muscaria@O939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292840" y="7823160"/>
            <a:ext cx="2972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Gloeophyllum_trabeum_ESTchimera_gb_EB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217600" y="7655040"/>
            <a:ext cx="2972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hanerochaete_chrysosporium_EST_gb|DV7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089440" y="785664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051280" y="87660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056320" y="799164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2468160" y="7518240"/>
            <a:ext cx="2058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oryzae@BAE6229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397600" y="7383600"/>
            <a:ext cx="2591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agnaporthe grisea 70-15@XP_3651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2366640" y="7248600"/>
            <a:ext cx="2667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haeosphaeria nodorum SN15@EAT763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246040" y="7113600"/>
            <a:ext cx="320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otryotinia fuckeliana B05.10@XP_0015565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363760" y="6978600"/>
            <a:ext cx="2515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Neurospora crassa OR74A@XP_9587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288160" y="6843600"/>
            <a:ext cx="312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niger CBS 513.88@XP_001396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317320" y="670860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terreus NIH2624@XP_0012177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2480760" y="6540480"/>
            <a:ext cx="2058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oryzae@BAE5558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2427840" y="65530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6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2194200" y="670572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2410200" y="6405480"/>
            <a:ext cx="2286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Gibberella zeae PH-1@XP_38948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2288160" y="6270480"/>
            <a:ext cx="312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niger CBS 513.88@XP_00140180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2392200" y="6135840"/>
            <a:ext cx="2058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oryzae@BAE600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2292120" y="600084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terreus NIH2624@XP_0012093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2384280" y="5865840"/>
            <a:ext cx="2896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nidulans FGSC A4@XP_66367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2258640" y="5730840"/>
            <a:ext cx="2820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fumigatus Af293@XP_7552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2277720" y="559584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spergillus clavatus NRRL 1@XP_0012678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2305440" y="64054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2310480" y="566424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2208960" y="58323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2145240" y="704700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2145240" y="60357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2081880" y="751824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046960" y="624852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1894680" y="85978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6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970640" y="652320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2184840" y="5486400"/>
            <a:ext cx="236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elaginella kraussiana@AAW8063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2226240" y="5292720"/>
            <a:ext cx="2515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Ophioglossum reticulatum@AAW806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2246760" y="5157720"/>
            <a:ext cx="19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ellia epiphylla@AAW806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2298600" y="5022720"/>
            <a:ext cx="198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Equisetum arvense@AAW806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2152440" y="4888080"/>
            <a:ext cx="198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Isoetes lacustris@AAW806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2280960" y="4753080"/>
            <a:ext cx="2134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teridium aquilinum@AAW806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337480" y="4619520"/>
            <a:ext cx="175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inus pinaster@AAP8525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2260440" y="4484520"/>
            <a:ext cx="19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inus sylvestris@AAL743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2329920" y="4349880"/>
            <a:ext cx="167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Ginkgo biloba@ABZ0412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2239560" y="4214880"/>
            <a:ext cx="198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Huperzia lucidula@AAW806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2230920" y="4044960"/>
            <a:ext cx="236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Lycopodium tristachyum@AAW8063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1946160" y="3909960"/>
            <a:ext cx="3658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hyscomitrella patens subsp. patens@XP_00176049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2282760" y="3776760"/>
            <a:ext cx="175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silotum nudum@AAW806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2185560" y="3641760"/>
            <a:ext cx="236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otrychium virginianum@AAW8064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2261160" y="3506760"/>
            <a:ext cx="167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edicago sativa@P279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2285640" y="3371760"/>
            <a:ext cx="1372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Glycine max@P279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2257920" y="3236760"/>
            <a:ext cx="1829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Lotus japonicus@BAF369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2226240" y="3102120"/>
            <a:ext cx="2058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olanum lycopersicum@P26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2236680" y="2967120"/>
            <a:ext cx="1829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Nicotiana tabacum@P2587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2268000" y="2798640"/>
            <a:ext cx="167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eta vulgaris@CAH1768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2198520" y="2664000"/>
            <a:ext cx="198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opulus trichocarpa@P457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2066760" y="252900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rassica rapa subsp. campestris@ABY896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2188080" y="2394000"/>
            <a:ext cx="2286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bidopsis thaliana@NP_18124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2250720" y="2259000"/>
            <a:ext cx="19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Coffea canephora@AAN3286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2226960" y="2124000"/>
            <a:ext cx="198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Manihot esculenta@AAK6027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288880" y="1989000"/>
            <a:ext cx="19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gastache rugosa@AAK156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2235960" y="1854360"/>
            <a:ext cx="175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Lactuca sativa@AAL5524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2208600" y="1719360"/>
            <a:ext cx="2058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etroselinum crispum@P2448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2284200" y="1550880"/>
            <a:ext cx="167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Daucus carota@BAC5697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2207160" y="1415880"/>
            <a:ext cx="175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Vitis vinifera@CAO621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2194560" y="1281240"/>
            <a:ext cx="175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Vitis vinifera@CAO6893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2396880" y="1146240"/>
            <a:ext cx="160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Zea mays@NP_0011053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284920" y="1011240"/>
            <a:ext cx="2286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Saccharum officinarum@ABM6337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2120760" y="876240"/>
            <a:ext cx="2210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Phyllostachys edulis@ABP9695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2230200" y="741240"/>
            <a:ext cx="1905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Bambusa oldhamii@AAR245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2192760" y="606600"/>
            <a:ext cx="1829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Triticum aestivum@Q432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2057760" y="471600"/>
            <a:ext cx="304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Oryza sativa Japonica Group@NP_00105332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1784880" y="785664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1965600" y="304812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1508400" y="914400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1505520" y="53038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1208880" y="713268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1508400" y="11582280"/>
            <a:ext cx="183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1132560" y="865656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1053360" y="14397120"/>
            <a:ext cx="122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9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1870200" y="2237580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1870200" y="2224080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 flipV="1">
            <a:off x="1870200" y="2224044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1844640" y="22510800"/>
            <a:ext cx="381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1844640" y="22309200"/>
            <a:ext cx="255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 flipV="1">
            <a:off x="1844640" y="22309200"/>
            <a:ext cx="180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1832040" y="22678920"/>
            <a:ext cx="381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1832040" y="2240928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 flipV="1">
            <a:off x="1832040" y="22408920"/>
            <a:ext cx="1440" cy="269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1793880" y="22543920"/>
            <a:ext cx="381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1793880" y="22105800"/>
            <a:ext cx="507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 flipV="1">
            <a:off x="1793880" y="22105440"/>
            <a:ext cx="1440" cy="438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1717560" y="22309200"/>
            <a:ext cx="763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1717560" y="21971160"/>
            <a:ext cx="1396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 flipV="1">
            <a:off x="1717560" y="21970800"/>
            <a:ext cx="1800" cy="338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1768320" y="21701160"/>
            <a:ext cx="1908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1768320" y="21566160"/>
            <a:ext cx="2667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 flipV="1">
            <a:off x="1768320" y="21565800"/>
            <a:ext cx="180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1730520" y="21836160"/>
            <a:ext cx="1648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1730520" y="21634560"/>
            <a:ext cx="378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 flipV="1">
            <a:off x="1730520" y="21634560"/>
            <a:ext cx="144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1692360" y="22140720"/>
            <a:ext cx="252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1692360" y="2173608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 flipV="1">
            <a:off x="1692360" y="21736080"/>
            <a:ext cx="1440" cy="404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1616040" y="21937680"/>
            <a:ext cx="763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1616040" y="21398040"/>
            <a:ext cx="3049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 flipV="1">
            <a:off x="1616040" y="21397680"/>
            <a:ext cx="1800" cy="539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1730520" y="20858040"/>
            <a:ext cx="12672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1730520" y="20723400"/>
            <a:ext cx="2412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 flipV="1">
            <a:off x="1730520" y="20723400"/>
            <a:ext cx="1440" cy="134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1692360" y="20993040"/>
            <a:ext cx="2793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1692360" y="20791440"/>
            <a:ext cx="381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 flipV="1">
            <a:off x="1692360" y="20791440"/>
            <a:ext cx="144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1654200" y="21128040"/>
            <a:ext cx="1904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1654200" y="2089296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 flipV="1">
            <a:off x="1654200" y="20892600"/>
            <a:ext cx="1440" cy="235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1616040" y="21263040"/>
            <a:ext cx="2667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1616040" y="2102796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 flipV="1">
            <a:off x="1616040" y="21027600"/>
            <a:ext cx="1800" cy="235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1577880" y="21667680"/>
            <a:ext cx="381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1577880" y="2116296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 flipV="1">
            <a:off x="1577880" y="21162960"/>
            <a:ext cx="1800" cy="50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1603440" y="20588400"/>
            <a:ext cx="2412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1603440" y="20453400"/>
            <a:ext cx="3301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 flipV="1">
            <a:off x="1603440" y="2045304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1539720" y="21398040"/>
            <a:ext cx="381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1539720" y="20521440"/>
            <a:ext cx="6372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 flipV="1">
            <a:off x="1539720" y="20521080"/>
            <a:ext cx="1800" cy="876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2174760" y="20319840"/>
            <a:ext cx="129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2174760" y="20150280"/>
            <a:ext cx="129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flipV="1">
            <a:off x="2174760" y="20149920"/>
            <a:ext cx="1800" cy="16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1374840" y="20959920"/>
            <a:ext cx="1648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1374840" y="20251800"/>
            <a:ext cx="7999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 flipV="1">
            <a:off x="1374840" y="20251440"/>
            <a:ext cx="1440" cy="708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1996920" y="19610280"/>
            <a:ext cx="180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1996920" y="19477080"/>
            <a:ext cx="18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1704960" y="19745280"/>
            <a:ext cx="1396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1704960" y="19543680"/>
            <a:ext cx="2919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 flipV="1">
            <a:off x="1704960" y="19543680"/>
            <a:ext cx="144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1654200" y="19880280"/>
            <a:ext cx="889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1654200" y="1964520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 flipV="1">
            <a:off x="1654200" y="19644840"/>
            <a:ext cx="1440" cy="235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1501920" y="19342080"/>
            <a:ext cx="3301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1501920" y="19207080"/>
            <a:ext cx="3175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 flipV="1">
            <a:off x="1501920" y="1920672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1400040" y="19780200"/>
            <a:ext cx="254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1400040" y="19273680"/>
            <a:ext cx="10188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 flipV="1">
            <a:off x="1400040" y="19273320"/>
            <a:ext cx="1800" cy="506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1362240" y="20015280"/>
            <a:ext cx="1774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1362240" y="19510200"/>
            <a:ext cx="378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 flipV="1">
            <a:off x="1362240" y="19509840"/>
            <a:ext cx="1440" cy="505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1273320" y="20588400"/>
            <a:ext cx="1015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1273320" y="19780200"/>
            <a:ext cx="889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 flipV="1">
            <a:off x="1273320" y="19779840"/>
            <a:ext cx="1440" cy="808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1692360" y="19072080"/>
            <a:ext cx="266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1692360" y="18902520"/>
            <a:ext cx="1904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 flipV="1">
            <a:off x="1692360" y="18902160"/>
            <a:ext cx="1440" cy="169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1704960" y="18767520"/>
            <a:ext cx="1904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1704960" y="18633960"/>
            <a:ext cx="17784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 flipV="1">
            <a:off x="1704960" y="18633600"/>
            <a:ext cx="1440" cy="133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1603440" y="19004040"/>
            <a:ext cx="889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1603440" y="18700920"/>
            <a:ext cx="1015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1" name=""/>
          <p:cNvGrpSpPr/>
          <p:nvPr/>
        </p:nvGrpSpPr>
        <p:grpSpPr>
          <a:xfrm>
            <a:off x="1082520" y="8783640"/>
            <a:ext cx="1625760" cy="11403720"/>
            <a:chOff x="1082520" y="8783640"/>
            <a:chExt cx="1625760" cy="11403720"/>
          </a:xfrm>
        </p:grpSpPr>
        <p:sp>
          <p:nvSpPr>
            <p:cNvPr id="352" name=""/>
            <p:cNvSpPr/>
            <p:nvPr/>
          </p:nvSpPr>
          <p:spPr>
            <a:xfrm flipV="1">
              <a:off x="1603440" y="18699120"/>
              <a:ext cx="1440" cy="302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1552680" y="18496800"/>
              <a:ext cx="3553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1552680" y="18362160"/>
              <a:ext cx="2286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 flipV="1">
              <a:off x="1552680" y="1836216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1374840" y="18834120"/>
              <a:ext cx="2286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1374840" y="18429840"/>
              <a:ext cx="17784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 flipV="1">
              <a:off x="1374840" y="18429840"/>
              <a:ext cx="1440" cy="403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1235160" y="20182680"/>
              <a:ext cx="3816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1235160" y="18631440"/>
              <a:ext cx="1396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 flipV="1">
              <a:off x="1235160" y="18631440"/>
              <a:ext cx="1440" cy="1550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1857240" y="18227160"/>
              <a:ext cx="50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1857240" y="18092520"/>
              <a:ext cx="50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 flipV="1">
              <a:off x="1857240" y="18092520"/>
              <a:ext cx="180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1844640" y="17957880"/>
              <a:ext cx="1270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1844640" y="17822880"/>
              <a:ext cx="1144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 flipV="1">
              <a:off x="1844640" y="17822880"/>
              <a:ext cx="180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1806480" y="18160200"/>
              <a:ext cx="50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1806480" y="17889840"/>
              <a:ext cx="3816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 flipV="1">
              <a:off x="1806480" y="17889480"/>
              <a:ext cx="1800" cy="270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1984320" y="17519040"/>
              <a:ext cx="2286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1984320" y="17384400"/>
              <a:ext cx="763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 flipV="1">
              <a:off x="1984320" y="17384400"/>
              <a:ext cx="180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2035080" y="16980120"/>
              <a:ext cx="637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2035080" y="16845480"/>
              <a:ext cx="255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 flipV="1">
              <a:off x="2035080" y="16845480"/>
              <a:ext cx="180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2009880" y="17114760"/>
              <a:ext cx="633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2009880" y="16912440"/>
              <a:ext cx="252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 flipV="1">
              <a:off x="2009880" y="16912440"/>
              <a:ext cx="1440" cy="20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1959120" y="17249760"/>
              <a:ext cx="19044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1959120" y="17013600"/>
              <a:ext cx="50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 flipV="1">
              <a:off x="1959120" y="17013240"/>
              <a:ext cx="1440" cy="235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1882800" y="17452080"/>
              <a:ext cx="1015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1882800" y="17114760"/>
              <a:ext cx="763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 flipV="1">
              <a:off x="1882800" y="17114400"/>
              <a:ext cx="1440" cy="337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1832040" y="17654040"/>
              <a:ext cx="2286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1832040" y="17283240"/>
              <a:ext cx="5076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 flipV="1">
              <a:off x="1832040" y="17282880"/>
              <a:ext cx="1440" cy="370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1730520" y="18024480"/>
              <a:ext cx="7596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1730520" y="17485560"/>
              <a:ext cx="1015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 flipV="1">
              <a:off x="1730520" y="17485200"/>
              <a:ext cx="1440" cy="538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2162160" y="16272000"/>
              <a:ext cx="381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2162160" y="16137360"/>
              <a:ext cx="50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 flipV="1">
              <a:off x="2162160" y="1613736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2111400" y="16406640"/>
              <a:ext cx="889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2111400" y="16203960"/>
              <a:ext cx="5076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 flipV="1">
              <a:off x="2111400" y="16203960"/>
              <a:ext cx="1440" cy="20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2060640" y="16002360"/>
              <a:ext cx="889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2060640" y="15867720"/>
              <a:ext cx="633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 flipV="1">
              <a:off x="2060640" y="1586772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1984320" y="16305480"/>
              <a:ext cx="1270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1984320" y="15934680"/>
              <a:ext cx="763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 flipV="1">
              <a:off x="1984320" y="15934320"/>
              <a:ext cx="1800" cy="370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1908000" y="16574760"/>
              <a:ext cx="3304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1908000" y="16137360"/>
              <a:ext cx="763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 flipV="1">
              <a:off x="1908000" y="16137000"/>
              <a:ext cx="1800" cy="437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1844640" y="16710480"/>
              <a:ext cx="19044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1844640" y="16339680"/>
              <a:ext cx="633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 flipV="1">
              <a:off x="1844640" y="16339320"/>
              <a:ext cx="1800" cy="370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1882800" y="15733080"/>
              <a:ext cx="126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1882800" y="15597360"/>
              <a:ext cx="252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 flipV="1">
              <a:off x="1882800" y="15597360"/>
              <a:ext cx="1440" cy="135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1743120" y="16508160"/>
              <a:ext cx="1015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1743120" y="15665040"/>
              <a:ext cx="1396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 flipV="1">
              <a:off x="1743120" y="15664680"/>
              <a:ext cx="1440" cy="842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1641600" y="17755200"/>
              <a:ext cx="889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1641600" y="16103880"/>
              <a:ext cx="1015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 flipV="1">
              <a:off x="1641600" y="16103520"/>
              <a:ext cx="1440" cy="1651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1717560" y="15294240"/>
              <a:ext cx="2923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1717560" y="15159600"/>
              <a:ext cx="3304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 flipV="1">
              <a:off x="1717560" y="15159600"/>
              <a:ext cx="180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1514520" y="15462720"/>
              <a:ext cx="3934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1514520" y="15226560"/>
              <a:ext cx="20304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 flipV="1">
              <a:off x="1514520" y="15226200"/>
              <a:ext cx="1440" cy="235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1349280" y="16912440"/>
              <a:ext cx="2923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1349280" y="15361200"/>
              <a:ext cx="16524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 flipV="1">
              <a:off x="1349280" y="15361200"/>
              <a:ext cx="1800" cy="1550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1425600" y="14889960"/>
              <a:ext cx="3175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1425600" y="14754240"/>
              <a:ext cx="29196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 flipV="1">
              <a:off x="1425600" y="14754240"/>
              <a:ext cx="1440" cy="135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1336680" y="15024960"/>
              <a:ext cx="43164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1336680" y="14822280"/>
              <a:ext cx="889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 flipV="1">
              <a:off x="1336680" y="14822280"/>
              <a:ext cx="1440" cy="20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1311120" y="16137360"/>
              <a:ext cx="381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1311120" y="14923440"/>
              <a:ext cx="255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 flipV="1">
              <a:off x="1311120" y="14923080"/>
              <a:ext cx="1800" cy="1213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1704960" y="14619600"/>
              <a:ext cx="17784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1704960" y="14484960"/>
              <a:ext cx="2412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 flipV="1">
              <a:off x="1704960" y="1448496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1488960" y="14552640"/>
              <a:ext cx="2160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1488960" y="14350320"/>
              <a:ext cx="7495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 flipV="1">
              <a:off x="1488960" y="14350320"/>
              <a:ext cx="1800" cy="20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1768320" y="14047200"/>
              <a:ext cx="17784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>
              <a:off x="1768320" y="13912560"/>
              <a:ext cx="2160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 flipV="1">
              <a:off x="1768320" y="13912560"/>
              <a:ext cx="180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1590840" y="14215320"/>
              <a:ext cx="2538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1590840" y="13979520"/>
              <a:ext cx="1774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 flipV="1">
              <a:off x="1590840" y="13979160"/>
              <a:ext cx="1440" cy="235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1387440" y="14451480"/>
              <a:ext cx="1015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1387440" y="14114160"/>
              <a:ext cx="2034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 flipV="1">
              <a:off x="1387440" y="14113800"/>
              <a:ext cx="1800" cy="337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1488960" y="13641840"/>
              <a:ext cx="3556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1488960" y="13507200"/>
              <a:ext cx="3430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 flipV="1">
              <a:off x="1488960" y="13507200"/>
              <a:ext cx="180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1387440" y="13776840"/>
              <a:ext cx="29196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1387440" y="13575240"/>
              <a:ext cx="1015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 flipV="1">
              <a:off x="1387440" y="13575240"/>
              <a:ext cx="1800" cy="201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1324080" y="14283360"/>
              <a:ext cx="633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1324080" y="13676400"/>
              <a:ext cx="633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 flipV="1">
              <a:off x="1324080" y="13676040"/>
              <a:ext cx="1440" cy="60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1273320" y="15530400"/>
              <a:ext cx="378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1273320" y="13979520"/>
              <a:ext cx="50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 flipV="1">
              <a:off x="1273320" y="13979520"/>
              <a:ext cx="1440" cy="1550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1197000" y="19407600"/>
              <a:ext cx="381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1197000" y="14754240"/>
              <a:ext cx="763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 flipV="1">
              <a:off x="1197000" y="14753880"/>
              <a:ext cx="1440" cy="4653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1565280" y="13237920"/>
              <a:ext cx="1015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1565280" y="13102920"/>
              <a:ext cx="1270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 flipV="1">
              <a:off x="1565280" y="1310292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1374840" y="13372560"/>
              <a:ext cx="266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1374840" y="13169880"/>
              <a:ext cx="19044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 flipV="1">
              <a:off x="1374840" y="13169880"/>
              <a:ext cx="1440" cy="20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1882800" y="12799080"/>
              <a:ext cx="126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1882800" y="12664440"/>
              <a:ext cx="144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 flipV="1">
              <a:off x="1882800" y="1266444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1438200" y="12968280"/>
              <a:ext cx="5587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1438200" y="12732120"/>
              <a:ext cx="4446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 flipV="1">
              <a:off x="1438200" y="12731760"/>
              <a:ext cx="1800" cy="235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1552680" y="12529800"/>
              <a:ext cx="4824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1552680" y="12394800"/>
              <a:ext cx="11556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 flipV="1">
              <a:off x="1552680" y="1239480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1298520" y="12833640"/>
              <a:ext cx="1396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1298520" y="12462840"/>
              <a:ext cx="2541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 flipV="1">
              <a:off x="1298520" y="12462480"/>
              <a:ext cx="1800" cy="370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1082520" y="13271400"/>
              <a:ext cx="2923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1082520" y="12664440"/>
              <a:ext cx="2160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 flipV="1">
              <a:off x="1082520" y="12664080"/>
              <a:ext cx="1800" cy="60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1730520" y="12125520"/>
              <a:ext cx="2412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1730520" y="11990520"/>
              <a:ext cx="21564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 flipV="1">
              <a:off x="1730520" y="1199052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1273320" y="12260160"/>
              <a:ext cx="5331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1273320" y="12057480"/>
              <a:ext cx="4572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 flipV="1">
              <a:off x="1273320" y="12057480"/>
              <a:ext cx="1440" cy="20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1908000" y="11716200"/>
              <a:ext cx="381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1908000" y="11548080"/>
              <a:ext cx="511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 flipV="1">
              <a:off x="1908000" y="11547720"/>
              <a:ext cx="1800" cy="168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1755720" y="11855880"/>
              <a:ext cx="2160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1755720" y="11615040"/>
              <a:ext cx="1522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 flipV="1">
              <a:off x="1755720" y="11615040"/>
              <a:ext cx="1800" cy="240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1133640" y="12159000"/>
              <a:ext cx="1396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1133640" y="11749680"/>
              <a:ext cx="6220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 flipV="1">
              <a:off x="1133640" y="11749680"/>
              <a:ext cx="1440" cy="408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1654200" y="11413440"/>
              <a:ext cx="4953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1654200" y="11277720"/>
              <a:ext cx="4698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 flipV="1">
              <a:off x="1654200" y="11277720"/>
              <a:ext cx="1440" cy="135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2289240" y="10738800"/>
              <a:ext cx="381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2289240" y="10604160"/>
              <a:ext cx="50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 flipV="1">
              <a:off x="2289240" y="1060416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2149560" y="10873440"/>
              <a:ext cx="19044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2149560" y="10670760"/>
              <a:ext cx="1396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 flipV="1">
              <a:off x="2149560" y="10670760"/>
              <a:ext cx="1440" cy="20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2212920" y="10469160"/>
              <a:ext cx="50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2212920" y="10299960"/>
              <a:ext cx="637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 flipV="1">
              <a:off x="2212920" y="10299600"/>
              <a:ext cx="1800" cy="168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2098800" y="10772280"/>
              <a:ext cx="5076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2098800" y="10368000"/>
              <a:ext cx="1141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 flipV="1">
              <a:off x="2098800" y="10368000"/>
              <a:ext cx="1440" cy="403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2022480" y="11008080"/>
              <a:ext cx="17784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2022480" y="10570680"/>
              <a:ext cx="763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 flipV="1">
              <a:off x="2022480" y="10570320"/>
              <a:ext cx="1440" cy="437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2111400" y="10165320"/>
              <a:ext cx="763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2111400" y="10030680"/>
              <a:ext cx="1396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 flipV="1">
              <a:off x="2111400" y="1003068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1959120" y="10806480"/>
              <a:ext cx="633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1959120" y="10098360"/>
              <a:ext cx="1522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 flipV="1">
              <a:off x="1959120" y="10098000"/>
              <a:ext cx="1440" cy="708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1577880" y="11143080"/>
              <a:ext cx="41904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1577880" y="10434960"/>
              <a:ext cx="38124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 flipV="1">
              <a:off x="1577880" y="10434600"/>
              <a:ext cx="1800" cy="708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2048040" y="9761040"/>
              <a:ext cx="1648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2048040" y="9626400"/>
              <a:ext cx="25380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 flipV="1">
              <a:off x="2048040" y="962640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1946160" y="9895680"/>
              <a:ext cx="39384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1946160" y="9693360"/>
              <a:ext cx="1018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 flipV="1">
              <a:off x="1946160" y="9693360"/>
              <a:ext cx="1800" cy="20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1362240" y="10806480"/>
              <a:ext cx="21564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1362240" y="9794520"/>
              <a:ext cx="5839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 flipV="1">
              <a:off x="1362240" y="9794160"/>
              <a:ext cx="1440" cy="1011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2225520" y="9356760"/>
              <a:ext cx="637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2225520" y="9221040"/>
              <a:ext cx="5112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 flipV="1">
              <a:off x="2225520" y="9221040"/>
              <a:ext cx="1800" cy="135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2174760" y="9052920"/>
              <a:ext cx="10188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2174760" y="8918280"/>
              <a:ext cx="889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 flipV="1">
              <a:off x="2174760" y="8918280"/>
              <a:ext cx="180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2098800" y="9289080"/>
              <a:ext cx="12672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2098800" y="8985960"/>
              <a:ext cx="759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 flipV="1">
              <a:off x="2098800" y="8985600"/>
              <a:ext cx="1440" cy="302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1844640" y="9491760"/>
              <a:ext cx="36828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1844640" y="9120960"/>
              <a:ext cx="2541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 flipV="1">
              <a:off x="1844640" y="9120600"/>
              <a:ext cx="1800" cy="370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2416320" y="8783640"/>
              <a:ext cx="50760" cy="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0" bIns="-43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2" name=""/>
          <p:cNvSpPr/>
          <p:nvPr/>
        </p:nvSpPr>
        <p:spPr>
          <a:xfrm>
            <a:off x="2416320" y="8648640"/>
            <a:ext cx="759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 flipV="1">
            <a:off x="2416320" y="864828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2378160" y="8244000"/>
            <a:ext cx="889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2378160" y="8109000"/>
            <a:ext cx="1270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 flipV="1">
            <a:off x="2378160" y="810864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2352600" y="7974000"/>
            <a:ext cx="1778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2352600" y="7805880"/>
            <a:ext cx="1270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 flipV="1">
            <a:off x="2352600" y="7805520"/>
            <a:ext cx="1800" cy="168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2327400" y="817704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2327400" y="7873920"/>
            <a:ext cx="252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 flipV="1">
            <a:off x="2327400" y="7873920"/>
            <a:ext cx="1440" cy="303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2289240" y="8379000"/>
            <a:ext cx="1522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>
            <a:off x="2289240" y="8042400"/>
            <a:ext cx="3816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 flipV="1">
            <a:off x="2289240" y="8042040"/>
            <a:ext cx="1440" cy="336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2098800" y="8513640"/>
            <a:ext cx="36828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2098800" y="8210520"/>
            <a:ext cx="1904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 flipV="1">
            <a:off x="2098800" y="8210520"/>
            <a:ext cx="1440" cy="303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>
            <a:off x="2060640" y="8717040"/>
            <a:ext cx="35568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2060640" y="8345520"/>
            <a:ext cx="381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 flipV="1">
            <a:off x="2060640" y="8345520"/>
            <a:ext cx="1440" cy="371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2340000" y="7670880"/>
            <a:ext cx="3175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2340000" y="7535880"/>
            <a:ext cx="2793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 flipV="1">
            <a:off x="2340000" y="753552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2340000" y="7400880"/>
            <a:ext cx="2160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2340000" y="7265880"/>
            <a:ext cx="25380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 flipV="1">
            <a:off x="2340000" y="726552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2289240" y="7604280"/>
            <a:ext cx="5076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2289240" y="733428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 flipV="1">
            <a:off x="2289240" y="7334280"/>
            <a:ext cx="1440" cy="270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2479680" y="6861240"/>
            <a:ext cx="1396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2479680" y="6692760"/>
            <a:ext cx="19044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 flipV="1">
            <a:off x="2479680" y="6692760"/>
            <a:ext cx="1440" cy="168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2428920" y="6996240"/>
            <a:ext cx="1778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2428920" y="6794640"/>
            <a:ext cx="507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 flipV="1">
            <a:off x="2428920" y="6794640"/>
            <a:ext cx="144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>
            <a:off x="2263680" y="7130880"/>
            <a:ext cx="2793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>
            <a:off x="2263680" y="6896160"/>
            <a:ext cx="16524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 flipV="1">
            <a:off x="2263680" y="6896160"/>
            <a:ext cx="1800" cy="23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>
            <a:off x="2467080" y="6423120"/>
            <a:ext cx="1396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2467080" y="6288120"/>
            <a:ext cx="1141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 flipV="1">
            <a:off x="2467080" y="628776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2530440" y="5883120"/>
            <a:ext cx="255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2530440" y="5748480"/>
            <a:ext cx="507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 flipV="1">
            <a:off x="2530440" y="5748480"/>
            <a:ext cx="1800" cy="134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2479680" y="6018120"/>
            <a:ext cx="1778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2479680" y="5816520"/>
            <a:ext cx="507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 flipV="1">
            <a:off x="2479680" y="5816520"/>
            <a:ext cx="144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2416320" y="6153120"/>
            <a:ext cx="1774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2416320" y="5918040"/>
            <a:ext cx="633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 flipV="1">
            <a:off x="2416320" y="5917680"/>
            <a:ext cx="1440" cy="235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2314440" y="6356520"/>
            <a:ext cx="15264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2314440" y="6018120"/>
            <a:ext cx="1018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 flipV="1">
            <a:off x="2314440" y="6018120"/>
            <a:ext cx="1800" cy="338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2212920" y="6558120"/>
            <a:ext cx="3938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2212920" y="6188040"/>
            <a:ext cx="1015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 flipV="1">
            <a:off x="2212920" y="6188040"/>
            <a:ext cx="1800" cy="370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2149560" y="6996240"/>
            <a:ext cx="1141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2149560" y="6389640"/>
            <a:ext cx="633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 flipV="1">
            <a:off x="2149560" y="6389280"/>
            <a:ext cx="1440" cy="606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>
            <a:off x="2085840" y="7469280"/>
            <a:ext cx="2034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2085840" y="6692760"/>
            <a:ext cx="6372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 flipV="1">
            <a:off x="2085840" y="6692400"/>
            <a:ext cx="1800" cy="776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2009880" y="8547120"/>
            <a:ext cx="507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>
            <a:off x="2009880" y="7097760"/>
            <a:ext cx="759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"/>
          <p:cNvSpPr/>
          <p:nvPr/>
        </p:nvSpPr>
        <p:spPr>
          <a:xfrm flipV="1">
            <a:off x="2009880" y="7097760"/>
            <a:ext cx="1440" cy="1449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"/>
          <p:cNvSpPr/>
          <p:nvPr/>
        </p:nvSpPr>
        <p:spPr>
          <a:xfrm>
            <a:off x="2365200" y="5310360"/>
            <a:ext cx="511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"/>
          <p:cNvSpPr/>
          <p:nvPr/>
        </p:nvSpPr>
        <p:spPr>
          <a:xfrm>
            <a:off x="2365200" y="5175360"/>
            <a:ext cx="637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"/>
          <p:cNvSpPr/>
          <p:nvPr/>
        </p:nvSpPr>
        <p:spPr>
          <a:xfrm flipV="1">
            <a:off x="2365200" y="5175000"/>
            <a:ext cx="180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2352600" y="5445000"/>
            <a:ext cx="7632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2352600" y="5243400"/>
            <a:ext cx="126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 flipV="1">
            <a:off x="2352600" y="5243400"/>
            <a:ext cx="180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2289240" y="5613480"/>
            <a:ext cx="889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2289240" y="5345280"/>
            <a:ext cx="6336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 flipV="1">
            <a:off x="2289240" y="5344920"/>
            <a:ext cx="1440" cy="268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2403360" y="463716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2403360" y="450216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 flipV="1">
            <a:off x="2403360" y="4501800"/>
            <a:ext cx="180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2378160" y="4770360"/>
            <a:ext cx="1015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2378160" y="4568760"/>
            <a:ext cx="252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 flipV="1">
            <a:off x="2378160" y="4568760"/>
            <a:ext cx="144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2327400" y="4905360"/>
            <a:ext cx="1141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2327400" y="467028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 flipV="1">
            <a:off x="2327400" y="4669920"/>
            <a:ext cx="1440" cy="235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2352600" y="436716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2352600" y="4197240"/>
            <a:ext cx="507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 flipV="1">
            <a:off x="2352600" y="4197240"/>
            <a:ext cx="1800" cy="169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>
            <a:off x="2301840" y="4770360"/>
            <a:ext cx="255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2301840" y="4299120"/>
            <a:ext cx="507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 flipV="1">
            <a:off x="2301840" y="4298760"/>
            <a:ext cx="1800" cy="471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>
            <a:off x="2289240" y="5040360"/>
            <a:ext cx="633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>
            <a:off x="2289240" y="4535640"/>
            <a:ext cx="1260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 flipV="1">
            <a:off x="2289240" y="4535640"/>
            <a:ext cx="1440" cy="50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2263680" y="5479920"/>
            <a:ext cx="255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>
            <a:off x="2263680" y="4805280"/>
            <a:ext cx="255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 flipV="1">
            <a:off x="2263680" y="4805280"/>
            <a:ext cx="1800" cy="674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2314440" y="3927600"/>
            <a:ext cx="507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2314440" y="379404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 flipV="1">
            <a:off x="2314440" y="3793680"/>
            <a:ext cx="1800" cy="133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2276640" y="4062240"/>
            <a:ext cx="885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>
            <a:off x="2276640" y="3860640"/>
            <a:ext cx="3780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 flipV="1">
            <a:off x="2276640" y="3860640"/>
            <a:ext cx="144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2251080" y="514188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2251080" y="3962520"/>
            <a:ext cx="2556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 flipV="1">
            <a:off x="2251080" y="3962520"/>
            <a:ext cx="1440" cy="1179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"/>
          <p:cNvSpPr/>
          <p:nvPr/>
        </p:nvSpPr>
        <p:spPr>
          <a:xfrm>
            <a:off x="2352600" y="365904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"/>
          <p:cNvSpPr/>
          <p:nvPr/>
        </p:nvSpPr>
        <p:spPr>
          <a:xfrm>
            <a:off x="2352600" y="3524400"/>
            <a:ext cx="1260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"/>
          <p:cNvSpPr/>
          <p:nvPr/>
        </p:nvSpPr>
        <p:spPr>
          <a:xfrm flipV="1">
            <a:off x="2352600" y="3524400"/>
            <a:ext cx="1800" cy="134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2352600" y="3591000"/>
            <a:ext cx="18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2352600" y="338940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 flipV="1">
            <a:off x="2352600" y="3389400"/>
            <a:ext cx="180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>
            <a:off x="2378160" y="3254400"/>
            <a:ext cx="126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"/>
          <p:cNvSpPr/>
          <p:nvPr/>
        </p:nvSpPr>
        <p:spPr>
          <a:xfrm>
            <a:off x="2378160" y="3119400"/>
            <a:ext cx="144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"/>
          <p:cNvSpPr/>
          <p:nvPr/>
        </p:nvSpPr>
        <p:spPr>
          <a:xfrm flipV="1">
            <a:off x="2378160" y="311904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"/>
          <p:cNvSpPr/>
          <p:nvPr/>
        </p:nvSpPr>
        <p:spPr>
          <a:xfrm>
            <a:off x="2352600" y="3186000"/>
            <a:ext cx="255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"/>
          <p:cNvSpPr/>
          <p:nvPr/>
        </p:nvSpPr>
        <p:spPr>
          <a:xfrm>
            <a:off x="2352600" y="2951280"/>
            <a:ext cx="3816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"/>
          <p:cNvSpPr/>
          <p:nvPr/>
        </p:nvSpPr>
        <p:spPr>
          <a:xfrm flipV="1">
            <a:off x="2352600" y="2951280"/>
            <a:ext cx="1800" cy="23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"/>
          <p:cNvSpPr/>
          <p:nvPr/>
        </p:nvSpPr>
        <p:spPr>
          <a:xfrm>
            <a:off x="2390760" y="2681280"/>
            <a:ext cx="126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"/>
          <p:cNvSpPr/>
          <p:nvPr/>
        </p:nvSpPr>
        <p:spPr>
          <a:xfrm>
            <a:off x="2390760" y="2546280"/>
            <a:ext cx="126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"/>
          <p:cNvSpPr/>
          <p:nvPr/>
        </p:nvSpPr>
        <p:spPr>
          <a:xfrm flipV="1">
            <a:off x="2390760" y="254592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"/>
          <p:cNvSpPr/>
          <p:nvPr/>
        </p:nvSpPr>
        <p:spPr>
          <a:xfrm>
            <a:off x="2352600" y="2816280"/>
            <a:ext cx="255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"/>
          <p:cNvSpPr/>
          <p:nvPr/>
        </p:nvSpPr>
        <p:spPr>
          <a:xfrm>
            <a:off x="2352600" y="2612880"/>
            <a:ext cx="3816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"/>
          <p:cNvSpPr/>
          <p:nvPr/>
        </p:nvSpPr>
        <p:spPr>
          <a:xfrm flipV="1">
            <a:off x="2352600" y="2612520"/>
            <a:ext cx="1800" cy="203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"/>
          <p:cNvSpPr/>
          <p:nvPr/>
        </p:nvSpPr>
        <p:spPr>
          <a:xfrm>
            <a:off x="2340000" y="308448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"/>
          <p:cNvSpPr/>
          <p:nvPr/>
        </p:nvSpPr>
        <p:spPr>
          <a:xfrm>
            <a:off x="2340000" y="2714760"/>
            <a:ext cx="1260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"/>
          <p:cNvSpPr/>
          <p:nvPr/>
        </p:nvSpPr>
        <p:spPr>
          <a:xfrm flipV="1">
            <a:off x="2340000" y="2714400"/>
            <a:ext cx="1440" cy="369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"/>
          <p:cNvSpPr/>
          <p:nvPr/>
        </p:nvSpPr>
        <p:spPr>
          <a:xfrm>
            <a:off x="2365200" y="2276640"/>
            <a:ext cx="1296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"/>
          <p:cNvSpPr/>
          <p:nvPr/>
        </p:nvSpPr>
        <p:spPr>
          <a:xfrm>
            <a:off x="2365200" y="2141640"/>
            <a:ext cx="511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"/>
          <p:cNvSpPr/>
          <p:nvPr/>
        </p:nvSpPr>
        <p:spPr>
          <a:xfrm flipV="1">
            <a:off x="2365200" y="2141280"/>
            <a:ext cx="180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"/>
          <p:cNvSpPr/>
          <p:nvPr/>
        </p:nvSpPr>
        <p:spPr>
          <a:xfrm>
            <a:off x="2378160" y="1871640"/>
            <a:ext cx="126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"/>
          <p:cNvSpPr/>
          <p:nvPr/>
        </p:nvSpPr>
        <p:spPr>
          <a:xfrm>
            <a:off x="2378160" y="1703520"/>
            <a:ext cx="144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"/>
          <p:cNvSpPr/>
          <p:nvPr/>
        </p:nvSpPr>
        <p:spPr>
          <a:xfrm flipV="1">
            <a:off x="2378160" y="1703160"/>
            <a:ext cx="1440" cy="168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"/>
          <p:cNvSpPr/>
          <p:nvPr/>
        </p:nvSpPr>
        <p:spPr>
          <a:xfrm>
            <a:off x="2352600" y="2006640"/>
            <a:ext cx="255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"/>
          <p:cNvSpPr/>
          <p:nvPr/>
        </p:nvSpPr>
        <p:spPr>
          <a:xfrm>
            <a:off x="2352600" y="1770120"/>
            <a:ext cx="255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"/>
          <p:cNvSpPr/>
          <p:nvPr/>
        </p:nvSpPr>
        <p:spPr>
          <a:xfrm flipV="1">
            <a:off x="2352600" y="1769760"/>
            <a:ext cx="1800" cy="236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"/>
          <p:cNvSpPr/>
          <p:nvPr/>
        </p:nvSpPr>
        <p:spPr>
          <a:xfrm>
            <a:off x="2352600" y="220824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"/>
          <p:cNvSpPr/>
          <p:nvPr/>
        </p:nvSpPr>
        <p:spPr>
          <a:xfrm>
            <a:off x="2352600" y="1905120"/>
            <a:ext cx="18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"/>
          <p:cNvSpPr/>
          <p:nvPr/>
        </p:nvSpPr>
        <p:spPr>
          <a:xfrm flipV="1">
            <a:off x="2352600" y="1905120"/>
            <a:ext cx="1800" cy="303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"/>
          <p:cNvSpPr/>
          <p:nvPr/>
        </p:nvSpPr>
        <p:spPr>
          <a:xfrm>
            <a:off x="2340000" y="2039760"/>
            <a:ext cx="1260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"/>
          <p:cNvSpPr/>
          <p:nvPr/>
        </p:nvSpPr>
        <p:spPr>
          <a:xfrm>
            <a:off x="2340000" y="156852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"/>
          <p:cNvSpPr/>
          <p:nvPr/>
        </p:nvSpPr>
        <p:spPr>
          <a:xfrm flipV="1">
            <a:off x="2340000" y="1568160"/>
            <a:ext cx="1440" cy="471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"/>
          <p:cNvSpPr/>
          <p:nvPr/>
        </p:nvSpPr>
        <p:spPr>
          <a:xfrm>
            <a:off x="2340000" y="241128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"/>
          <p:cNvSpPr/>
          <p:nvPr/>
        </p:nvSpPr>
        <p:spPr>
          <a:xfrm>
            <a:off x="2340000" y="1803240"/>
            <a:ext cx="144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"/>
          <p:cNvSpPr/>
          <p:nvPr/>
        </p:nvSpPr>
        <p:spPr>
          <a:xfrm flipV="1">
            <a:off x="2340000" y="1802880"/>
            <a:ext cx="1440" cy="608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"/>
          <p:cNvSpPr/>
          <p:nvPr/>
        </p:nvSpPr>
        <p:spPr>
          <a:xfrm>
            <a:off x="2327400" y="288288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"/>
          <p:cNvSpPr/>
          <p:nvPr/>
        </p:nvSpPr>
        <p:spPr>
          <a:xfrm>
            <a:off x="2327400" y="2108160"/>
            <a:ext cx="126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"/>
          <p:cNvSpPr/>
          <p:nvPr/>
        </p:nvSpPr>
        <p:spPr>
          <a:xfrm flipV="1">
            <a:off x="2327400" y="2108160"/>
            <a:ext cx="1440" cy="77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"/>
          <p:cNvSpPr/>
          <p:nvPr/>
        </p:nvSpPr>
        <p:spPr>
          <a:xfrm>
            <a:off x="2327400" y="2511360"/>
            <a:ext cx="14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"/>
          <p:cNvSpPr/>
          <p:nvPr/>
        </p:nvSpPr>
        <p:spPr>
          <a:xfrm>
            <a:off x="2327400" y="1433520"/>
            <a:ext cx="378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"/>
          <p:cNvSpPr/>
          <p:nvPr/>
        </p:nvSpPr>
        <p:spPr>
          <a:xfrm flipV="1">
            <a:off x="2327400" y="1433520"/>
            <a:ext cx="1440" cy="1077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"/>
          <p:cNvSpPr/>
          <p:nvPr/>
        </p:nvSpPr>
        <p:spPr>
          <a:xfrm>
            <a:off x="2314440" y="3489480"/>
            <a:ext cx="381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"/>
          <p:cNvSpPr/>
          <p:nvPr/>
        </p:nvSpPr>
        <p:spPr>
          <a:xfrm>
            <a:off x="2314440" y="1973160"/>
            <a:ext cx="129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"/>
          <p:cNvSpPr/>
          <p:nvPr/>
        </p:nvSpPr>
        <p:spPr>
          <a:xfrm flipV="1">
            <a:off x="2314440" y="1973160"/>
            <a:ext cx="1800" cy="15163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"/>
          <p:cNvSpPr/>
          <p:nvPr/>
        </p:nvSpPr>
        <p:spPr>
          <a:xfrm>
            <a:off x="2454120" y="1298520"/>
            <a:ext cx="129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"/>
          <p:cNvSpPr/>
          <p:nvPr/>
        </p:nvSpPr>
        <p:spPr>
          <a:xfrm>
            <a:off x="2454120" y="1163520"/>
            <a:ext cx="18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"/>
          <p:cNvSpPr/>
          <p:nvPr/>
        </p:nvSpPr>
        <p:spPr>
          <a:xfrm flipV="1">
            <a:off x="2454120" y="1163160"/>
            <a:ext cx="180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"/>
          <p:cNvSpPr/>
          <p:nvPr/>
        </p:nvSpPr>
        <p:spPr>
          <a:xfrm>
            <a:off x="2327400" y="1028880"/>
            <a:ext cx="1260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"/>
          <p:cNvSpPr/>
          <p:nvPr/>
        </p:nvSpPr>
        <p:spPr>
          <a:xfrm>
            <a:off x="2327400" y="89388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"/>
          <p:cNvSpPr/>
          <p:nvPr/>
        </p:nvSpPr>
        <p:spPr>
          <a:xfrm flipV="1">
            <a:off x="2327400" y="89352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"/>
          <p:cNvSpPr/>
          <p:nvPr/>
        </p:nvSpPr>
        <p:spPr>
          <a:xfrm>
            <a:off x="2340000" y="75888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"/>
          <p:cNvSpPr/>
          <p:nvPr/>
        </p:nvSpPr>
        <p:spPr>
          <a:xfrm>
            <a:off x="2340000" y="623880"/>
            <a:ext cx="14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"/>
          <p:cNvSpPr/>
          <p:nvPr/>
        </p:nvSpPr>
        <p:spPr>
          <a:xfrm flipV="1">
            <a:off x="2340000" y="623520"/>
            <a:ext cx="1440" cy="13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"/>
          <p:cNvSpPr/>
          <p:nvPr/>
        </p:nvSpPr>
        <p:spPr>
          <a:xfrm>
            <a:off x="2327400" y="960480"/>
            <a:ext cx="14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"/>
          <p:cNvSpPr/>
          <p:nvPr/>
        </p:nvSpPr>
        <p:spPr>
          <a:xfrm>
            <a:off x="2327400" y="690480"/>
            <a:ext cx="126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"/>
          <p:cNvSpPr/>
          <p:nvPr/>
        </p:nvSpPr>
        <p:spPr>
          <a:xfrm flipV="1">
            <a:off x="2327400" y="690480"/>
            <a:ext cx="1440" cy="270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"/>
          <p:cNvSpPr/>
          <p:nvPr/>
        </p:nvSpPr>
        <p:spPr>
          <a:xfrm>
            <a:off x="2314440" y="1230480"/>
            <a:ext cx="13968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"/>
          <p:cNvSpPr/>
          <p:nvPr/>
        </p:nvSpPr>
        <p:spPr>
          <a:xfrm>
            <a:off x="2314440" y="825480"/>
            <a:ext cx="129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"/>
          <p:cNvSpPr/>
          <p:nvPr/>
        </p:nvSpPr>
        <p:spPr>
          <a:xfrm flipV="1">
            <a:off x="2314440" y="825120"/>
            <a:ext cx="1800" cy="405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"/>
          <p:cNvSpPr/>
          <p:nvPr/>
        </p:nvSpPr>
        <p:spPr>
          <a:xfrm>
            <a:off x="2289240" y="2714760"/>
            <a:ext cx="2520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"/>
          <p:cNvSpPr/>
          <p:nvPr/>
        </p:nvSpPr>
        <p:spPr>
          <a:xfrm>
            <a:off x="2289240" y="1028880"/>
            <a:ext cx="2520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"/>
          <p:cNvSpPr/>
          <p:nvPr/>
        </p:nvSpPr>
        <p:spPr>
          <a:xfrm flipV="1">
            <a:off x="2289240" y="1028520"/>
            <a:ext cx="1440" cy="1685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"/>
          <p:cNvSpPr/>
          <p:nvPr/>
        </p:nvSpPr>
        <p:spPr>
          <a:xfrm>
            <a:off x="2225520" y="4568760"/>
            <a:ext cx="255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"/>
          <p:cNvSpPr/>
          <p:nvPr/>
        </p:nvSpPr>
        <p:spPr>
          <a:xfrm>
            <a:off x="2225520" y="1871640"/>
            <a:ext cx="637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"/>
          <p:cNvSpPr/>
          <p:nvPr/>
        </p:nvSpPr>
        <p:spPr>
          <a:xfrm flipV="1">
            <a:off x="2225520" y="1871640"/>
            <a:ext cx="1800" cy="2697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"/>
          <p:cNvSpPr/>
          <p:nvPr/>
        </p:nvSpPr>
        <p:spPr>
          <a:xfrm>
            <a:off x="1793880" y="7805880"/>
            <a:ext cx="2160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"/>
          <p:cNvSpPr/>
          <p:nvPr/>
        </p:nvSpPr>
        <p:spPr>
          <a:xfrm>
            <a:off x="1793880" y="3219480"/>
            <a:ext cx="4316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"/>
          <p:cNvSpPr/>
          <p:nvPr/>
        </p:nvSpPr>
        <p:spPr>
          <a:xfrm flipV="1">
            <a:off x="1793880" y="3219480"/>
            <a:ext cx="1440" cy="4586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"/>
          <p:cNvSpPr/>
          <p:nvPr/>
        </p:nvSpPr>
        <p:spPr>
          <a:xfrm>
            <a:off x="1438200" y="9323280"/>
            <a:ext cx="40644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"/>
          <p:cNvSpPr/>
          <p:nvPr/>
        </p:nvSpPr>
        <p:spPr>
          <a:xfrm>
            <a:off x="1438200" y="5513400"/>
            <a:ext cx="35568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"/>
          <p:cNvSpPr/>
          <p:nvPr/>
        </p:nvSpPr>
        <p:spPr>
          <a:xfrm flipV="1">
            <a:off x="1438200" y="5513040"/>
            <a:ext cx="1800" cy="3809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"/>
          <p:cNvSpPr/>
          <p:nvPr/>
        </p:nvSpPr>
        <p:spPr>
          <a:xfrm>
            <a:off x="1324080" y="10301400"/>
            <a:ext cx="381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"/>
          <p:cNvSpPr/>
          <p:nvPr/>
        </p:nvSpPr>
        <p:spPr>
          <a:xfrm>
            <a:off x="1324080" y="7400880"/>
            <a:ext cx="1141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"/>
          <p:cNvSpPr/>
          <p:nvPr/>
        </p:nvSpPr>
        <p:spPr>
          <a:xfrm flipV="1">
            <a:off x="1324080" y="7400520"/>
            <a:ext cx="1440" cy="2900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"/>
          <p:cNvSpPr/>
          <p:nvPr/>
        </p:nvSpPr>
        <p:spPr>
          <a:xfrm>
            <a:off x="1184400" y="11345760"/>
            <a:ext cx="46980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"/>
          <p:cNvSpPr/>
          <p:nvPr/>
        </p:nvSpPr>
        <p:spPr>
          <a:xfrm>
            <a:off x="1184400" y="8852040"/>
            <a:ext cx="13968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"/>
          <p:cNvSpPr/>
          <p:nvPr/>
        </p:nvSpPr>
        <p:spPr>
          <a:xfrm flipV="1">
            <a:off x="1184400" y="8851680"/>
            <a:ext cx="1440" cy="2493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"/>
          <p:cNvSpPr/>
          <p:nvPr/>
        </p:nvSpPr>
        <p:spPr>
          <a:xfrm>
            <a:off x="1108080" y="11957040"/>
            <a:ext cx="255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"/>
          <p:cNvSpPr/>
          <p:nvPr/>
        </p:nvSpPr>
        <p:spPr>
          <a:xfrm>
            <a:off x="1108080" y="10098000"/>
            <a:ext cx="7632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"/>
          <p:cNvSpPr/>
          <p:nvPr/>
        </p:nvSpPr>
        <p:spPr>
          <a:xfrm flipV="1">
            <a:off x="1108080" y="10098000"/>
            <a:ext cx="1440" cy="1859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"/>
          <p:cNvSpPr/>
          <p:nvPr/>
        </p:nvSpPr>
        <p:spPr>
          <a:xfrm>
            <a:off x="1031760" y="12968280"/>
            <a:ext cx="5076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"/>
          <p:cNvSpPr/>
          <p:nvPr/>
        </p:nvSpPr>
        <p:spPr>
          <a:xfrm>
            <a:off x="1031760" y="11009160"/>
            <a:ext cx="7632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"/>
          <p:cNvSpPr/>
          <p:nvPr/>
        </p:nvSpPr>
        <p:spPr>
          <a:xfrm flipV="1">
            <a:off x="1031760" y="11009160"/>
            <a:ext cx="1800" cy="1959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"/>
          <p:cNvSpPr/>
          <p:nvPr/>
        </p:nvSpPr>
        <p:spPr>
          <a:xfrm>
            <a:off x="1031760" y="17083080"/>
            <a:ext cx="16524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"/>
          <p:cNvSpPr/>
          <p:nvPr/>
        </p:nvSpPr>
        <p:spPr>
          <a:xfrm>
            <a:off x="1031760" y="11990520"/>
            <a:ext cx="180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"/>
          <p:cNvSpPr/>
          <p:nvPr/>
        </p:nvSpPr>
        <p:spPr>
          <a:xfrm flipV="1">
            <a:off x="1031760" y="11990520"/>
            <a:ext cx="1800" cy="509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"/>
          <p:cNvSpPr/>
          <p:nvPr/>
        </p:nvSpPr>
        <p:spPr>
          <a:xfrm>
            <a:off x="5580000" y="353880"/>
            <a:ext cx="520920" cy="5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"/>
          <p:cNvSpPr/>
          <p:nvPr/>
        </p:nvSpPr>
        <p:spPr>
          <a:xfrm flipV="1">
            <a:off x="5580000" y="218880"/>
            <a:ext cx="1800" cy="269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"/>
          <p:cNvSpPr/>
          <p:nvPr/>
        </p:nvSpPr>
        <p:spPr>
          <a:xfrm flipV="1">
            <a:off x="6100920" y="218880"/>
            <a:ext cx="1440" cy="269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"/>
          <p:cNvSpPr/>
          <p:nvPr/>
        </p:nvSpPr>
        <p:spPr>
          <a:xfrm>
            <a:off x="5705280" y="152280"/>
            <a:ext cx="22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20T17:01:22Z</dcterms:created>
  <dc:creator>Institut Pasteur</dc:creator>
  <dc:description/>
  <dc:language>en-US</dc:language>
  <cp:lastModifiedBy>simonetta gribaldo</cp:lastModifiedBy>
  <dcterms:modified xsi:type="dcterms:W3CDTF">2009-01-21T05:13:23Z</dcterms:modified>
  <cp:revision>7</cp:revision>
  <dc:subject/>
  <dc:title>Présentation PowerPoint</dc:title>
</cp:coreProperties>
</file>